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2E7FF-3831-4343-8570-E29DA66620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38086A-6489-4E8C-A95F-EE0620716B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45AD02-126D-41B2-8DA9-DEC495FD0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D97850-8D0E-4668-9E95-3F8A171D17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972341-0BF1-4903-A52B-40A0CFBBD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10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466DF-4C7A-489F-B9C9-892C0EFA36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54FDBF-AC78-45BD-9031-0E9137AE7F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3111EF-19B7-4255-937E-1D770E58C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4E91CD-42B2-4297-86FC-99F6A9066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656003-7DFD-43B1-A852-C72D1686A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612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721E467-CC6E-4BA0-9181-995468FFC8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DBCDB6-86E1-4E28-88E8-49F92B457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03F404-0B4A-41EF-A0FD-247FC1C0E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A263D1-1B8F-46DD-8E7D-759C462ED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9A17BD-B4A0-4ADF-899A-215C09D82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1CFC6-AE13-449E-A329-A91B8CA290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4A2107-1B1D-4C23-B43B-D04B81EC0A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390B0E-78FA-454B-826D-12DB648183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3470D1-203E-4F90-8A34-701D9401C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3E3661-70A4-4470-9501-3BCBF1DB6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835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5F5D0C-4EA4-4340-942B-45726A5A7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8A9365-0ABD-43C0-A2B4-BEF9BA0EE8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2E1278-7C1A-45C4-BA2B-64A8E0BF2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5DE623-4F2A-46C4-B012-9C38556DF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8CC2E6-94A6-489D-A172-C69C773B6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67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CF3BFE-40C7-4A7A-99E1-3FC31EC9F5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9FD50D-6442-46A7-A8D2-8335501485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939F70-88BD-4E33-B8F8-BD7D3D40BD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F7EA5D-B64F-44AB-90F1-A4A04A7C4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ED1635-7C83-45F2-8859-2B0B714B5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12127F-5C91-49FF-AFD7-4F50FD822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921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8D84D9-BAC3-4137-A79F-D01BF083D1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1B06A1-5338-44CE-B52B-AE4FFD77BF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D9AEE4-27AE-4D3A-B4EB-29A6CEEAF2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12AA5C2-3A81-4C15-A91A-B413F09563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67DD0D-E494-4192-B494-8AA6B7BF24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97FB54-272F-45A1-ABEA-EC7CC475FC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7383AC8-6939-4166-A2CE-7BA57DB833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CA1C90-2FDA-466C-9928-9C2B44848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435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5DEC8F-3ABE-4ECE-8D79-D7AF52CA93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2C6EE9-D894-47A5-9E5F-55B73C5BFD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D594BB5-BF73-4065-9BD1-6DC0CE11A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63647C-25F0-4FD0-AB4F-0A980DEBB4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739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0F2ED6C-9A3C-4613-BAB3-211719F10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11F7443-8ED5-4BE8-A7C5-A4427218F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DC4CE6-AEAC-4CD0-B0FB-D5713EF13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485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2540C6-7C60-4334-8B29-B39D54DC69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FE26EF-7430-4EB9-836E-B39C029C23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983B4D-13A9-4837-A3AB-F5E881A118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2D2A67-1E04-4433-B237-6C1DDCF5F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AE3BE1-EC96-495A-96E8-8106B29F8C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2991A7-5BF4-4667-B8F8-DA6246894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767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CBD158-A01E-4710-A5B4-66DB3D650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2BE78E5-22E3-4CB5-B28E-C529454CEC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B4976E-5542-4E10-81F6-0B607F6118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3504A7-A14A-4245-9421-12B242AD3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8C998D-112C-4EA1-BBF4-785D035C7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B71734-3B4C-40EC-8954-A34A6BF87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813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C891C66-57F8-4EDD-9241-57D58C4ED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E34BDF-6A3D-41F8-A8F1-28FB701096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A90989-5276-46DA-82D1-9067115638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77DFE3-2628-4BD9-8BC2-CD1F7840F44F}" type="datetimeFigureOut">
              <a:rPr lang="en-US" smtClean="0"/>
              <a:t>5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47D34F-1530-4F84-A691-C3192ADBE6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1532FE-41E1-4233-BCD9-E6E7D58B22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DB65A-4A55-4219-A822-53B2581355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541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F810DE71-73A5-DD47-240A-4D559731F550}"/>
              </a:ext>
            </a:extLst>
          </p:cNvPr>
          <p:cNvGrpSpPr/>
          <p:nvPr/>
        </p:nvGrpSpPr>
        <p:grpSpPr>
          <a:xfrm>
            <a:off x="126325" y="582498"/>
            <a:ext cx="7368538" cy="2447528"/>
            <a:chOff x="150574" y="1675644"/>
            <a:chExt cx="7368538" cy="2447528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7289E639-B485-B306-86CE-163982A7C0EF}"/>
                </a:ext>
              </a:extLst>
            </p:cNvPr>
            <p:cNvGrpSpPr/>
            <p:nvPr/>
          </p:nvGrpSpPr>
          <p:grpSpPr>
            <a:xfrm>
              <a:off x="286637" y="2044976"/>
              <a:ext cx="7232475" cy="2078196"/>
              <a:chOff x="1070689" y="748894"/>
              <a:chExt cx="7232475" cy="2078196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BF0F2CAD-634B-4423-B911-F18CDA7A2F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70689" y="1118226"/>
                <a:ext cx="2273444" cy="1708864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04D30D74-9FAD-415A-8FF8-498FFDBA39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550204" y="1118226"/>
                <a:ext cx="2273444" cy="1697505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0DF27FAA-0246-4649-A03A-C09B22B9FC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029719" y="1118226"/>
                <a:ext cx="2273445" cy="1701286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604F2CA3-97EB-4A8B-8458-4CD7D103AE55}"/>
                  </a:ext>
                </a:extLst>
              </p:cNvPr>
              <p:cNvSpPr txBox="1"/>
              <p:nvPr/>
            </p:nvSpPr>
            <p:spPr>
              <a:xfrm>
                <a:off x="1777645" y="748894"/>
                <a:ext cx="85953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Calcein</a:t>
                </a:r>
                <a:endParaRPr lang="en-US" dirty="0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8C43A5C6-11EA-4DA0-BDBD-3D73F78F21C1}"/>
                  </a:ext>
                </a:extLst>
              </p:cNvPr>
              <p:cNvSpPr txBox="1"/>
              <p:nvPr/>
            </p:nvSpPr>
            <p:spPr>
              <a:xfrm>
                <a:off x="4105933" y="748894"/>
                <a:ext cx="116198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Brightfield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5271A96-258A-4F4F-AA30-B74DC700BA1E}"/>
                  </a:ext>
                </a:extLst>
              </p:cNvPr>
              <p:cNvSpPr txBox="1"/>
              <p:nvPr/>
            </p:nvSpPr>
            <p:spPr>
              <a:xfrm>
                <a:off x="6768062" y="748894"/>
                <a:ext cx="79675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Merge</a:t>
                </a: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B4AD1E1-0575-86F0-E32E-00E9E2B13BFE}"/>
                </a:ext>
              </a:extLst>
            </p:cNvPr>
            <p:cNvSpPr txBox="1"/>
            <p:nvPr/>
          </p:nvSpPr>
          <p:spPr>
            <a:xfrm>
              <a:off x="150574" y="1675644"/>
              <a:ext cx="3767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.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CCA4B064-05D8-6855-FA03-7F9BC90DB4F3}"/>
              </a:ext>
            </a:extLst>
          </p:cNvPr>
          <p:cNvGrpSpPr/>
          <p:nvPr/>
        </p:nvGrpSpPr>
        <p:grpSpPr>
          <a:xfrm>
            <a:off x="7494863" y="582498"/>
            <a:ext cx="4365895" cy="3430142"/>
            <a:chOff x="7539468" y="1276670"/>
            <a:chExt cx="4365895" cy="343014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5E9C2CE-CEFB-81F0-B1D2-1E4AF7E72AA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906876" y="1461336"/>
              <a:ext cx="3998487" cy="3245476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1F17FA4-C8A7-02E8-29B4-7F3AB775FB5D}"/>
                </a:ext>
              </a:extLst>
            </p:cNvPr>
            <p:cNvSpPr txBox="1"/>
            <p:nvPr/>
          </p:nvSpPr>
          <p:spPr>
            <a:xfrm>
              <a:off x="7539468" y="1276670"/>
              <a:ext cx="3674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.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E1790792-C2B1-5683-B8B2-F4885D116466}"/>
              </a:ext>
            </a:extLst>
          </p:cNvPr>
          <p:cNvSpPr txBox="1"/>
          <p:nvPr/>
        </p:nvSpPr>
        <p:spPr>
          <a:xfrm>
            <a:off x="635392" y="4012640"/>
            <a:ext cx="10648737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rtl="0">
              <a:spcBef>
                <a:spcPts val="0"/>
              </a:spcBef>
              <a:spcAft>
                <a:spcPts val="0"/>
              </a:spcAft>
            </a:pP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Figure S1. Non-Melanoma Cell Line Capture Using The Melanoma Assay</a:t>
            </a:r>
            <a:endParaRPr lang="en-US" b="0" dirty="0">
              <a:effectLst/>
            </a:endParaRPr>
          </a:p>
          <a:p>
            <a:pPr algn="just" rtl="0">
              <a:spcBef>
                <a:spcPts val="0"/>
              </a:spcBef>
              <a:spcAft>
                <a:spcPts val="0"/>
              </a:spcAft>
            </a:pPr>
            <a:br>
              <a:rPr lang="en-US" b="0" dirty="0">
                <a:effectLst/>
              </a:rPr>
            </a:b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rostate cancer cell line capture with the melanoma assay antibodies. A. LNCaP (Lymph Node Carcinoma of the Prostate) cells were captured with the melanoma assay antibodies: NG-2 and CD146. Samples were run in duplicate. Each dot represents the average capture efficiency of the two replicates in a single run. The experiment was performed twice. B. Representative 10X images of the LNCaP cells are shown. The merged image includes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alcein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nd Brightfield. All scale bars shown are 10 µM. </a:t>
            </a:r>
            <a:endParaRPr lang="en-US" b="0" dirty="0">
              <a:effectLst/>
            </a:endParaRPr>
          </a:p>
          <a:p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51996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24</TotalTime>
  <Words>111</Words>
  <Application>Microsoft Macintosh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C. Mannino</dc:creator>
  <cp:lastModifiedBy>Vincent Ma</cp:lastModifiedBy>
  <cp:revision>9</cp:revision>
  <dcterms:created xsi:type="dcterms:W3CDTF">2024-08-15T22:53:54Z</dcterms:created>
  <dcterms:modified xsi:type="dcterms:W3CDTF">2025-05-14T21:09:47Z</dcterms:modified>
</cp:coreProperties>
</file>